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14ECF5-11DA-4FA1-BAE1-328CDF8F3D8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7572E8-48CD-4FCC-838E-DC972AEE665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50C722-D609-4DEE-889C-45681E84AC1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FD2A11-AA7E-4054-B5BD-13C036CC911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69D927-2074-45F6-A6DA-7E5DD578947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326302-0E3F-4AE2-9EFE-0C1277583E6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D1818C-DAA0-4B5B-AF78-DD6202097C3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191026-C725-42D5-8527-DCE1DBD102E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6F0871-3A42-42D9-BF6E-FD13EE84E51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B50214-CFA2-4351-8719-DEC6B00DC59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39DB6D-0426-4E28-BD73-1AE7C7FB65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4F0C7B-2470-4BF4-939B-6A6719C5BD5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C67168D-3B82-448C-9141-AC2CC3BB7D9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AutoShape 83"/>
          <p:cNvSpPr/>
          <p:nvPr/>
        </p:nvSpPr>
        <p:spPr>
          <a:xfrm rot="5400000">
            <a:off x="447840" y="4429080"/>
            <a:ext cx="304560" cy="285840"/>
          </a:xfrm>
          <a:prstGeom prst="rightArrow">
            <a:avLst>
              <a:gd name="adj1" fmla="val 45833"/>
              <a:gd name="adj2" fmla="val 65898"/>
            </a:avLst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68760" rIns="68760" tIns="34200" bIns="34200" anchor="t" anchorCtr="1" vert="eaVert" rot="10800000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AutoShape 83"/>
          <p:cNvSpPr/>
          <p:nvPr/>
        </p:nvSpPr>
        <p:spPr>
          <a:xfrm rot="10800000">
            <a:off x="7924320" y="3886200"/>
            <a:ext cx="173160" cy="285840"/>
          </a:xfrm>
          <a:prstGeom prst="rightArrow">
            <a:avLst>
              <a:gd name="adj1" fmla="val 45833"/>
              <a:gd name="adj2" fmla="val 65972"/>
            </a:avLst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68760" rIns="68760" tIns="34200" bIns="34200" anchor="ctr" rot="10800000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AutoShape 83"/>
          <p:cNvSpPr/>
          <p:nvPr/>
        </p:nvSpPr>
        <p:spPr>
          <a:xfrm rot="10800000">
            <a:off x="7009920" y="3886200"/>
            <a:ext cx="173160" cy="285840"/>
          </a:xfrm>
          <a:prstGeom prst="rightArrow">
            <a:avLst>
              <a:gd name="adj1" fmla="val 45833"/>
              <a:gd name="adj2" fmla="val 65972"/>
            </a:avLst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68760" rIns="68760" tIns="34200" bIns="34200" anchor="ctr" rot="10800000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AutoShape 83"/>
          <p:cNvSpPr/>
          <p:nvPr/>
        </p:nvSpPr>
        <p:spPr>
          <a:xfrm rot="10800000">
            <a:off x="5943240" y="3886200"/>
            <a:ext cx="173160" cy="285840"/>
          </a:xfrm>
          <a:prstGeom prst="rightArrow">
            <a:avLst>
              <a:gd name="adj1" fmla="val 45833"/>
              <a:gd name="adj2" fmla="val 65972"/>
            </a:avLst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68760" rIns="68760" tIns="34200" bIns="34200" anchor="ctr" rot="10800000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AutoShape 83"/>
          <p:cNvSpPr/>
          <p:nvPr/>
        </p:nvSpPr>
        <p:spPr>
          <a:xfrm rot="10800000">
            <a:off x="2895120" y="3886200"/>
            <a:ext cx="171720" cy="285840"/>
          </a:xfrm>
          <a:prstGeom prst="rightArrow">
            <a:avLst>
              <a:gd name="adj1" fmla="val 45833"/>
              <a:gd name="adj2" fmla="val 65972"/>
            </a:avLst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68760" rIns="68760" tIns="34200" bIns="34200" anchor="ctr" rot="10800000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AutoShape 83"/>
          <p:cNvSpPr/>
          <p:nvPr/>
        </p:nvSpPr>
        <p:spPr>
          <a:xfrm rot="10800000">
            <a:off x="1523520" y="1752480"/>
            <a:ext cx="171720" cy="285840"/>
          </a:xfrm>
          <a:prstGeom prst="rightArrow">
            <a:avLst>
              <a:gd name="adj1" fmla="val 45833"/>
              <a:gd name="adj2" fmla="val 65972"/>
            </a:avLst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68760" rIns="68760" tIns="34200" bIns="34200" anchor="ctr" rot="10800000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AutoShape 83"/>
          <p:cNvSpPr/>
          <p:nvPr/>
        </p:nvSpPr>
        <p:spPr>
          <a:xfrm rot="10800000">
            <a:off x="2666520" y="1752480"/>
            <a:ext cx="171720" cy="285840"/>
          </a:xfrm>
          <a:prstGeom prst="rightArrow">
            <a:avLst>
              <a:gd name="adj1" fmla="val 45833"/>
              <a:gd name="adj2" fmla="val 65972"/>
            </a:avLst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68760" rIns="68760" tIns="34200" bIns="34200" anchor="ctr" rot="10800000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AutoShape 83"/>
          <p:cNvSpPr/>
          <p:nvPr/>
        </p:nvSpPr>
        <p:spPr>
          <a:xfrm rot="10800000">
            <a:off x="3733920" y="1752480"/>
            <a:ext cx="171360" cy="285840"/>
          </a:xfrm>
          <a:prstGeom prst="rightArrow">
            <a:avLst>
              <a:gd name="adj1" fmla="val 45833"/>
              <a:gd name="adj2" fmla="val 65972"/>
            </a:avLst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68760" rIns="68760" tIns="34200" bIns="34200" anchor="ctr" rot="10800000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AutoShape 83"/>
          <p:cNvSpPr/>
          <p:nvPr/>
        </p:nvSpPr>
        <p:spPr>
          <a:xfrm rot="10800000">
            <a:off x="4723920" y="1752480"/>
            <a:ext cx="171720" cy="285840"/>
          </a:xfrm>
          <a:prstGeom prst="rightArrow">
            <a:avLst>
              <a:gd name="adj1" fmla="val 45833"/>
              <a:gd name="adj2" fmla="val 65972"/>
            </a:avLst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68760" rIns="68760" tIns="34200" bIns="34200" anchor="ctr" rot="10800000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AutoShape 83"/>
          <p:cNvSpPr/>
          <p:nvPr/>
        </p:nvSpPr>
        <p:spPr>
          <a:xfrm rot="5400000">
            <a:off x="447480" y="2295360"/>
            <a:ext cx="304920" cy="285840"/>
          </a:xfrm>
          <a:prstGeom prst="rightArrow">
            <a:avLst>
              <a:gd name="adj1" fmla="val 45833"/>
              <a:gd name="adj2" fmla="val 65976"/>
            </a:avLst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68760" rIns="68760" tIns="34200" bIns="34200" anchor="t" anchorCtr="1" vert="eaVert" rot="10800000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AutoShape 83"/>
          <p:cNvSpPr/>
          <p:nvPr/>
        </p:nvSpPr>
        <p:spPr>
          <a:xfrm rot="5400000">
            <a:off x="8410320" y="3400200"/>
            <a:ext cx="381240" cy="285840"/>
          </a:xfrm>
          <a:prstGeom prst="rightArrow">
            <a:avLst>
              <a:gd name="adj1" fmla="val 45833"/>
              <a:gd name="adj2" fmla="val 65990"/>
            </a:avLst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68760" rIns="68760" tIns="34200" bIns="34200" anchor="t" anchorCtr="1" vert="eaVert" rot="10800000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AutoShape 10"/>
          <p:cNvSpPr/>
          <p:nvPr/>
        </p:nvSpPr>
        <p:spPr>
          <a:xfrm>
            <a:off x="1295280" y="752400"/>
            <a:ext cx="173160" cy="285840"/>
          </a:xfrm>
          <a:prstGeom prst="rightArrow">
            <a:avLst>
              <a:gd name="adj1" fmla="val 45833"/>
              <a:gd name="adj2" fmla="val 65972"/>
            </a:avLst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68760" rIns="68760" tIns="34200" bIns="342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7"/>
          <p:cNvSpPr/>
          <p:nvPr/>
        </p:nvSpPr>
        <p:spPr>
          <a:xfrm>
            <a:off x="3368520" y="457200"/>
            <a:ext cx="898560" cy="830160"/>
          </a:xfrm>
          <a:prstGeom prst="rect">
            <a:avLst/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68760" rIns="68760" tIns="34200" bIns="342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Reaction Cleanup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(96w plat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Brav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36"/>
          <p:cNvSpPr/>
          <p:nvPr/>
        </p:nvSpPr>
        <p:spPr>
          <a:xfrm>
            <a:off x="2438280" y="457200"/>
            <a:ext cx="762120" cy="982440"/>
          </a:xfrm>
          <a:prstGeom prst="rect">
            <a:avLst/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68760" rIns="68760" tIns="34200" bIns="342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FragPol Reaction                    (96w plat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Cycl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AutoShape 82"/>
          <p:cNvSpPr/>
          <p:nvPr/>
        </p:nvSpPr>
        <p:spPr>
          <a:xfrm>
            <a:off x="2286000" y="762120"/>
            <a:ext cx="171360" cy="285480"/>
          </a:xfrm>
          <a:prstGeom prst="rightArrow">
            <a:avLst>
              <a:gd name="adj1" fmla="val 45833"/>
              <a:gd name="adj2" fmla="val 65972"/>
            </a:avLst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68760" rIns="68760" tIns="34200" bIns="342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AutoShape 83"/>
          <p:cNvSpPr/>
          <p:nvPr/>
        </p:nvSpPr>
        <p:spPr>
          <a:xfrm>
            <a:off x="3200400" y="752400"/>
            <a:ext cx="171360" cy="285840"/>
          </a:xfrm>
          <a:prstGeom prst="rightArrow">
            <a:avLst>
              <a:gd name="adj1" fmla="val 45833"/>
              <a:gd name="adj2" fmla="val 65972"/>
            </a:avLst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68760" rIns="68760" tIns="34200" bIns="342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69"/>
          <p:cNvSpPr/>
          <p:nvPr/>
        </p:nvSpPr>
        <p:spPr>
          <a:xfrm>
            <a:off x="4419720" y="457200"/>
            <a:ext cx="1068120" cy="830160"/>
          </a:xfrm>
          <a:prstGeom prst="rect">
            <a:avLst/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68760" rIns="68760" tIns="34200" bIns="342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LoxP Adapter Ligation Setu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(96w plat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Brav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7"/>
          <p:cNvSpPr/>
          <p:nvPr/>
        </p:nvSpPr>
        <p:spPr>
          <a:xfrm>
            <a:off x="6799320" y="457200"/>
            <a:ext cx="973080" cy="830160"/>
          </a:xfrm>
          <a:prstGeom prst="rect">
            <a:avLst/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68760" rIns="68760" tIns="34200" bIns="342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Reaction Cleanup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(96w plat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Brav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74"/>
          <p:cNvSpPr/>
          <p:nvPr/>
        </p:nvSpPr>
        <p:spPr>
          <a:xfrm>
            <a:off x="5638680" y="457200"/>
            <a:ext cx="990720" cy="982440"/>
          </a:xfrm>
          <a:prstGeom prst="rect">
            <a:avLst/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68760" rIns="68760" tIns="34200" bIns="342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Adapter Ligation Reaction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(96w plat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Cycl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AutoShape 83"/>
          <p:cNvSpPr/>
          <p:nvPr/>
        </p:nvSpPr>
        <p:spPr>
          <a:xfrm>
            <a:off x="5486400" y="762120"/>
            <a:ext cx="171360" cy="285480"/>
          </a:xfrm>
          <a:prstGeom prst="rightArrow">
            <a:avLst>
              <a:gd name="adj1" fmla="val 45833"/>
              <a:gd name="adj2" fmla="val 65972"/>
            </a:avLst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68760" rIns="68760" tIns="34200" bIns="342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125"/>
          <p:cNvSpPr/>
          <p:nvPr/>
        </p:nvSpPr>
        <p:spPr>
          <a:xfrm>
            <a:off x="7924680" y="533520"/>
            <a:ext cx="914400" cy="677880"/>
          </a:xfrm>
          <a:prstGeom prst="rect">
            <a:avLst/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68760" rIns="68760" tIns="34200" bIns="342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Fill in Setu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(96w plat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Brav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6"/>
          <p:cNvSpPr/>
          <p:nvPr/>
        </p:nvSpPr>
        <p:spPr>
          <a:xfrm>
            <a:off x="1447920" y="457200"/>
            <a:ext cx="838080" cy="853200"/>
          </a:xfrm>
          <a:prstGeom prst="rect">
            <a:avLst/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FragPol Setu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(96w plat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Brav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36"/>
          <p:cNvSpPr/>
          <p:nvPr/>
        </p:nvSpPr>
        <p:spPr>
          <a:xfrm>
            <a:off x="5791320" y="1600200"/>
            <a:ext cx="892080" cy="830160"/>
          </a:xfrm>
          <a:prstGeom prst="rect">
            <a:avLst/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68760" rIns="68760" tIns="34200" bIns="342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Cre Rxn Setup                    (96w plat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Brav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74"/>
          <p:cNvSpPr/>
          <p:nvPr/>
        </p:nvSpPr>
        <p:spPr>
          <a:xfrm>
            <a:off x="4876920" y="1523880"/>
            <a:ext cx="761760" cy="830160"/>
          </a:xfrm>
          <a:prstGeom prst="rect">
            <a:avLst/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68760" rIns="68760" tIns="34200" bIns="342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Cre Reaction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(96w plat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Cycl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36"/>
          <p:cNvSpPr/>
          <p:nvPr/>
        </p:nvSpPr>
        <p:spPr>
          <a:xfrm>
            <a:off x="3886200" y="1523880"/>
            <a:ext cx="822240" cy="982440"/>
          </a:xfrm>
          <a:prstGeom prst="rect">
            <a:avLst/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68760" rIns="68760" tIns="34200" bIns="342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DNase Rxn Setup                    (96w plat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Brav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7"/>
          <p:cNvSpPr/>
          <p:nvPr/>
        </p:nvSpPr>
        <p:spPr>
          <a:xfrm>
            <a:off x="1676520" y="1523880"/>
            <a:ext cx="974520" cy="830160"/>
          </a:xfrm>
          <a:prstGeom prst="rect">
            <a:avLst/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68760" rIns="68760" tIns="34200" bIns="342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Reaction Cleanup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(96w plat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Brav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74"/>
          <p:cNvSpPr/>
          <p:nvPr/>
        </p:nvSpPr>
        <p:spPr>
          <a:xfrm>
            <a:off x="2819520" y="1523880"/>
            <a:ext cx="900000" cy="830160"/>
          </a:xfrm>
          <a:prstGeom prst="rect">
            <a:avLst/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68760" rIns="68760" tIns="34200" bIns="342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DNase Reaction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(96w plat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Cycl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AutoShape 82"/>
          <p:cNvSpPr/>
          <p:nvPr/>
        </p:nvSpPr>
        <p:spPr>
          <a:xfrm>
            <a:off x="1276200" y="2819520"/>
            <a:ext cx="171720" cy="285480"/>
          </a:xfrm>
          <a:prstGeom prst="rightArrow">
            <a:avLst>
              <a:gd name="adj1" fmla="val 45833"/>
              <a:gd name="adj2" fmla="val 65972"/>
            </a:avLst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68760" rIns="68760" tIns="34200" bIns="342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107"/>
          <p:cNvSpPr/>
          <p:nvPr/>
        </p:nvSpPr>
        <p:spPr>
          <a:xfrm>
            <a:off x="396720" y="1600200"/>
            <a:ext cx="1127160" cy="677880"/>
          </a:xfrm>
          <a:prstGeom prst="rect">
            <a:avLst/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68760" rIns="68760" tIns="34200" bIns="342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Shearing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(96w plat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 </a:t>
            </a: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Covaris E2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7"/>
          <p:cNvSpPr/>
          <p:nvPr/>
        </p:nvSpPr>
        <p:spPr>
          <a:xfrm>
            <a:off x="380880" y="2563920"/>
            <a:ext cx="892440" cy="830160"/>
          </a:xfrm>
          <a:prstGeom prst="rect">
            <a:avLst/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68760" rIns="68760" tIns="34200" bIns="342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Reaction Cleanup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(96w plat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Brav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AutoShape 82"/>
          <p:cNvSpPr/>
          <p:nvPr/>
        </p:nvSpPr>
        <p:spPr>
          <a:xfrm>
            <a:off x="2286000" y="2819520"/>
            <a:ext cx="171360" cy="285480"/>
          </a:xfrm>
          <a:prstGeom prst="rightArrow">
            <a:avLst>
              <a:gd name="adj1" fmla="val 45833"/>
              <a:gd name="adj2" fmla="val 65972"/>
            </a:avLst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68760" rIns="68760" tIns="34200" bIns="342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AutoShape 82"/>
          <p:cNvSpPr/>
          <p:nvPr/>
        </p:nvSpPr>
        <p:spPr>
          <a:xfrm>
            <a:off x="3276720" y="2819520"/>
            <a:ext cx="171360" cy="285480"/>
          </a:xfrm>
          <a:prstGeom prst="rightArrow">
            <a:avLst>
              <a:gd name="adj1" fmla="val 45833"/>
              <a:gd name="adj2" fmla="val 65972"/>
            </a:avLst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68760" rIns="68760" tIns="34200" bIns="342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6"/>
          <p:cNvSpPr/>
          <p:nvPr/>
        </p:nvSpPr>
        <p:spPr>
          <a:xfrm>
            <a:off x="1447920" y="2567160"/>
            <a:ext cx="871560" cy="853200"/>
          </a:xfrm>
          <a:prstGeom prst="rect">
            <a:avLst/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FragPol Setu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(96w plat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Brav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36"/>
          <p:cNvSpPr/>
          <p:nvPr/>
        </p:nvSpPr>
        <p:spPr>
          <a:xfrm>
            <a:off x="2438280" y="2590920"/>
            <a:ext cx="838440" cy="982440"/>
          </a:xfrm>
          <a:prstGeom prst="rect">
            <a:avLst/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68760" rIns="68760" tIns="34200" bIns="342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FragPol Reaction                    (96w plat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Cycl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7"/>
          <p:cNvSpPr/>
          <p:nvPr/>
        </p:nvSpPr>
        <p:spPr>
          <a:xfrm>
            <a:off x="3429000" y="2590920"/>
            <a:ext cx="974880" cy="830160"/>
          </a:xfrm>
          <a:prstGeom prst="rect">
            <a:avLst/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68760" rIns="68760" tIns="34200" bIns="342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Reaction Cleanup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(96w plat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Brav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117"/>
          <p:cNvSpPr/>
          <p:nvPr/>
        </p:nvSpPr>
        <p:spPr>
          <a:xfrm>
            <a:off x="4572000" y="2590920"/>
            <a:ext cx="1295280" cy="982440"/>
          </a:xfrm>
          <a:prstGeom prst="rect">
            <a:avLst/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68760" rIns="68760" tIns="34200" bIns="342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Binding to Immobilization Beads   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(96w plat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Rotato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36"/>
          <p:cNvSpPr/>
          <p:nvPr/>
        </p:nvSpPr>
        <p:spPr>
          <a:xfrm>
            <a:off x="7518240" y="2590920"/>
            <a:ext cx="1320840" cy="830160"/>
          </a:xfrm>
          <a:prstGeom prst="rect">
            <a:avLst/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68760" rIns="68760" tIns="34200" bIns="342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Paired End Adapter Ligation Setup                    (96w plat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Brav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117"/>
          <p:cNvSpPr/>
          <p:nvPr/>
        </p:nvSpPr>
        <p:spPr>
          <a:xfrm>
            <a:off x="8077320" y="3735360"/>
            <a:ext cx="761760" cy="982440"/>
          </a:xfrm>
          <a:prstGeom prst="rect">
            <a:avLst/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68760" rIns="68760" tIns="34200" bIns="342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PE Adapter Ligation        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(96w plat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Rotato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125"/>
          <p:cNvSpPr/>
          <p:nvPr/>
        </p:nvSpPr>
        <p:spPr>
          <a:xfrm>
            <a:off x="7162920" y="3733920"/>
            <a:ext cx="761760" cy="677880"/>
          </a:xfrm>
          <a:prstGeom prst="rect">
            <a:avLst/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68760" rIns="68760" tIns="34200" bIns="342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Fill in Setu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(96w plat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Brav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135"/>
          <p:cNvSpPr/>
          <p:nvPr/>
        </p:nvSpPr>
        <p:spPr>
          <a:xfrm>
            <a:off x="8001000" y="1523880"/>
            <a:ext cx="861840" cy="982440"/>
          </a:xfrm>
          <a:prstGeom prst="rect">
            <a:avLst/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68760" rIns="68760" tIns="34200" bIns="342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Fill in Reaction                    (96w plat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Cycl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7"/>
          <p:cNvSpPr/>
          <p:nvPr/>
        </p:nvSpPr>
        <p:spPr>
          <a:xfrm>
            <a:off x="6858000" y="1523880"/>
            <a:ext cx="957240" cy="830160"/>
          </a:xfrm>
          <a:prstGeom prst="rect">
            <a:avLst/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68760" rIns="68760" tIns="34200" bIns="342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Reaction Cleanup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(96w plat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Brav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135"/>
          <p:cNvSpPr/>
          <p:nvPr/>
        </p:nvSpPr>
        <p:spPr>
          <a:xfrm>
            <a:off x="6095880" y="3733920"/>
            <a:ext cx="914400" cy="830160"/>
          </a:xfrm>
          <a:prstGeom prst="rect">
            <a:avLst/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68760" rIns="68760" tIns="34200" bIns="342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Fill in Reaction                    (96w plat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Cycl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36"/>
          <p:cNvSpPr/>
          <p:nvPr/>
        </p:nvSpPr>
        <p:spPr>
          <a:xfrm>
            <a:off x="4572000" y="3733920"/>
            <a:ext cx="1371600" cy="677880"/>
          </a:xfrm>
          <a:prstGeom prst="rect">
            <a:avLst/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68760" rIns="68760" tIns="34200" bIns="342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Amplification Rxn Setu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(96w plat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Brav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 Box 135"/>
          <p:cNvSpPr/>
          <p:nvPr/>
        </p:nvSpPr>
        <p:spPr>
          <a:xfrm>
            <a:off x="3048120" y="3733920"/>
            <a:ext cx="1374480" cy="700920"/>
          </a:xfrm>
          <a:prstGeom prst="rect">
            <a:avLst/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Amplification Reaction                    (96w plat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Cycl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AutoShape 83"/>
          <p:cNvSpPr/>
          <p:nvPr/>
        </p:nvSpPr>
        <p:spPr>
          <a:xfrm>
            <a:off x="6629400" y="762120"/>
            <a:ext cx="173160" cy="285480"/>
          </a:xfrm>
          <a:prstGeom prst="rightArrow">
            <a:avLst>
              <a:gd name="adj1" fmla="val 45833"/>
              <a:gd name="adj2" fmla="val 65972"/>
            </a:avLst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68760" rIns="68760" tIns="34200" bIns="342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AutoShape 83"/>
          <p:cNvSpPr/>
          <p:nvPr/>
        </p:nvSpPr>
        <p:spPr>
          <a:xfrm>
            <a:off x="7772400" y="762120"/>
            <a:ext cx="171360" cy="285480"/>
          </a:xfrm>
          <a:prstGeom prst="rightArrow">
            <a:avLst>
              <a:gd name="adj1" fmla="val 45833"/>
              <a:gd name="adj2" fmla="val 65972"/>
            </a:avLst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68760" rIns="68760" tIns="34200" bIns="342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AutoShape 83"/>
          <p:cNvSpPr/>
          <p:nvPr/>
        </p:nvSpPr>
        <p:spPr>
          <a:xfrm rot="10800000">
            <a:off x="6686640" y="1752480"/>
            <a:ext cx="171360" cy="285840"/>
          </a:xfrm>
          <a:prstGeom prst="rightArrow">
            <a:avLst>
              <a:gd name="adj1" fmla="val 45833"/>
              <a:gd name="adj2" fmla="val 65972"/>
            </a:avLst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68760" rIns="68760" tIns="34200" bIns="34200" anchor="ctr" rot="10800000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AutoShape 83"/>
          <p:cNvSpPr/>
          <p:nvPr/>
        </p:nvSpPr>
        <p:spPr>
          <a:xfrm rot="5400000">
            <a:off x="8448840" y="1228680"/>
            <a:ext cx="304560" cy="285840"/>
          </a:xfrm>
          <a:prstGeom prst="rightArrow">
            <a:avLst>
              <a:gd name="adj1" fmla="val 45833"/>
              <a:gd name="adj2" fmla="val 65898"/>
            </a:avLst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68760" rIns="68760" tIns="34200" bIns="34200" anchor="t" anchorCtr="1" vert="eaVert" rot="10800000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AutoShape 83"/>
          <p:cNvSpPr/>
          <p:nvPr/>
        </p:nvSpPr>
        <p:spPr>
          <a:xfrm rot="10800000">
            <a:off x="7827480" y="1743120"/>
            <a:ext cx="173160" cy="285840"/>
          </a:xfrm>
          <a:prstGeom prst="rightArrow">
            <a:avLst>
              <a:gd name="adj1" fmla="val 45833"/>
              <a:gd name="adj2" fmla="val 65972"/>
            </a:avLst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68760" rIns="68760" tIns="34200" bIns="34200" anchor="ctr" rot="10800000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AutoShape 83"/>
          <p:cNvSpPr/>
          <p:nvPr/>
        </p:nvSpPr>
        <p:spPr>
          <a:xfrm rot="10800000">
            <a:off x="5619240" y="1752480"/>
            <a:ext cx="171720" cy="285840"/>
          </a:xfrm>
          <a:prstGeom prst="rightArrow">
            <a:avLst>
              <a:gd name="adj1" fmla="val 45833"/>
              <a:gd name="adj2" fmla="val 65972"/>
            </a:avLst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68760" rIns="68760" tIns="34200" bIns="34200" anchor="ctr" rot="10800000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AutoShape 82"/>
          <p:cNvSpPr/>
          <p:nvPr/>
        </p:nvSpPr>
        <p:spPr>
          <a:xfrm>
            <a:off x="4400640" y="2819520"/>
            <a:ext cx="171360" cy="285480"/>
          </a:xfrm>
          <a:prstGeom prst="rightArrow">
            <a:avLst>
              <a:gd name="adj1" fmla="val 45833"/>
              <a:gd name="adj2" fmla="val 65972"/>
            </a:avLst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68760" rIns="68760" tIns="34200" bIns="342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 Box 127"/>
          <p:cNvSpPr/>
          <p:nvPr/>
        </p:nvSpPr>
        <p:spPr>
          <a:xfrm>
            <a:off x="6019920" y="2590920"/>
            <a:ext cx="1295280" cy="830160"/>
          </a:xfrm>
          <a:prstGeom prst="rect">
            <a:avLst/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68760" rIns="68760" tIns="34200" bIns="342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Wash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Immobilization Bead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(96w plate)        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Brav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AutoShape 82"/>
          <p:cNvSpPr/>
          <p:nvPr/>
        </p:nvSpPr>
        <p:spPr>
          <a:xfrm>
            <a:off x="5867280" y="2819520"/>
            <a:ext cx="171720" cy="285480"/>
          </a:xfrm>
          <a:prstGeom prst="rightArrow">
            <a:avLst>
              <a:gd name="adj1" fmla="val 45833"/>
              <a:gd name="adj2" fmla="val 65972"/>
            </a:avLst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68760" rIns="68760" tIns="34200" bIns="342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AutoShape 83"/>
          <p:cNvSpPr/>
          <p:nvPr/>
        </p:nvSpPr>
        <p:spPr>
          <a:xfrm rot="10800000">
            <a:off x="4400640" y="3886200"/>
            <a:ext cx="171360" cy="285840"/>
          </a:xfrm>
          <a:prstGeom prst="rightArrow">
            <a:avLst>
              <a:gd name="adj1" fmla="val 45833"/>
              <a:gd name="adj2" fmla="val 65972"/>
            </a:avLst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68760" rIns="68760" tIns="34200" bIns="34200" anchor="ctr" rot="10800000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 Box 7"/>
          <p:cNvSpPr/>
          <p:nvPr/>
        </p:nvSpPr>
        <p:spPr>
          <a:xfrm>
            <a:off x="1695600" y="3740040"/>
            <a:ext cx="1199880" cy="677880"/>
          </a:xfrm>
          <a:prstGeom prst="rect">
            <a:avLst/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68760" rIns="68760" tIns="34200" bIns="342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Reaction Cleanup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(96w plat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Brav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AutoShape 133"/>
          <p:cNvSpPr/>
          <p:nvPr/>
        </p:nvSpPr>
        <p:spPr>
          <a:xfrm>
            <a:off x="3429000" y="4952880"/>
            <a:ext cx="171360" cy="285840"/>
          </a:xfrm>
          <a:prstGeom prst="rightArrow">
            <a:avLst>
              <a:gd name="adj1" fmla="val 45833"/>
              <a:gd name="adj2" fmla="val 65972"/>
            </a:avLst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68760" rIns="68760" tIns="34200" bIns="342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 Box 7"/>
          <p:cNvSpPr/>
          <p:nvPr/>
        </p:nvSpPr>
        <p:spPr>
          <a:xfrm>
            <a:off x="399960" y="3740040"/>
            <a:ext cx="1123920" cy="677880"/>
          </a:xfrm>
          <a:prstGeom prst="rect">
            <a:avLst/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68760" rIns="68760" tIns="34200" bIns="342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Reaction Cleanup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(96w plat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Brav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AutoShape 133"/>
          <p:cNvSpPr/>
          <p:nvPr/>
        </p:nvSpPr>
        <p:spPr>
          <a:xfrm>
            <a:off x="5562720" y="4952880"/>
            <a:ext cx="228600" cy="285840"/>
          </a:xfrm>
          <a:prstGeom prst="rightArrow">
            <a:avLst>
              <a:gd name="adj1" fmla="val 45833"/>
              <a:gd name="adj2" fmla="val 65972"/>
            </a:avLst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68760" rIns="68760" tIns="34200" bIns="342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 Box 117"/>
          <p:cNvSpPr/>
          <p:nvPr/>
        </p:nvSpPr>
        <p:spPr>
          <a:xfrm>
            <a:off x="380880" y="4724280"/>
            <a:ext cx="1295640" cy="830160"/>
          </a:xfrm>
          <a:prstGeom prst="rect">
            <a:avLst/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68760" rIns="68760" tIns="34200" bIns="342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Binding to Immobilization Bead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(96w  plate)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       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Rotato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AutoShape 133"/>
          <p:cNvSpPr/>
          <p:nvPr/>
        </p:nvSpPr>
        <p:spPr>
          <a:xfrm>
            <a:off x="4400640" y="4952880"/>
            <a:ext cx="171360" cy="285840"/>
          </a:xfrm>
          <a:prstGeom prst="rightArrow">
            <a:avLst>
              <a:gd name="adj1" fmla="val 45833"/>
              <a:gd name="adj2" fmla="val 65972"/>
            </a:avLst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68760" rIns="68760" tIns="34200" bIns="342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 Box 127"/>
          <p:cNvSpPr/>
          <p:nvPr/>
        </p:nvSpPr>
        <p:spPr>
          <a:xfrm>
            <a:off x="1828800" y="4724280"/>
            <a:ext cx="1600200" cy="982440"/>
          </a:xfrm>
          <a:prstGeom prst="rect">
            <a:avLst/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68760" rIns="68760" tIns="34200" bIns="342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Wash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Immobilization Beads         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(96w plat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Brav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 Box 131"/>
          <p:cNvSpPr/>
          <p:nvPr/>
        </p:nvSpPr>
        <p:spPr>
          <a:xfrm>
            <a:off x="3592440" y="4724280"/>
            <a:ext cx="827280" cy="677880"/>
          </a:xfrm>
          <a:prstGeom prst="rect">
            <a:avLst/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68760" rIns="68760" tIns="34200" bIns="342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DNA Mel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(96w plat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Brav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 Box 96"/>
          <p:cNvSpPr/>
          <p:nvPr/>
        </p:nvSpPr>
        <p:spPr>
          <a:xfrm>
            <a:off x="4572000" y="4724280"/>
            <a:ext cx="1030320" cy="830160"/>
          </a:xfrm>
          <a:prstGeom prst="rect">
            <a:avLst/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68760" rIns="68760" tIns="34200" bIns="342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Final Cleanup/  Concentration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(96w plat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Brav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 Box 5"/>
          <p:cNvSpPr/>
          <p:nvPr/>
        </p:nvSpPr>
        <p:spPr>
          <a:xfrm>
            <a:off x="304920" y="380880"/>
            <a:ext cx="990360" cy="1007640"/>
          </a:xfrm>
          <a:prstGeom prst="rect">
            <a:avLst/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Template Plate Creation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(2D barcoded tubes in 96-well format rack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AutoShape 82"/>
          <p:cNvSpPr/>
          <p:nvPr/>
        </p:nvSpPr>
        <p:spPr>
          <a:xfrm>
            <a:off x="7315200" y="2819520"/>
            <a:ext cx="171360" cy="285480"/>
          </a:xfrm>
          <a:prstGeom prst="rightArrow">
            <a:avLst>
              <a:gd name="adj1" fmla="val 45833"/>
              <a:gd name="adj2" fmla="val 65972"/>
            </a:avLst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68760" rIns="68760" tIns="34200" bIns="342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AutoShape 83"/>
          <p:cNvSpPr/>
          <p:nvPr/>
        </p:nvSpPr>
        <p:spPr>
          <a:xfrm rot="10800000">
            <a:off x="1523520" y="3911400"/>
            <a:ext cx="171720" cy="285480"/>
          </a:xfrm>
          <a:prstGeom prst="rightArrow">
            <a:avLst>
              <a:gd name="adj1" fmla="val 45833"/>
              <a:gd name="adj2" fmla="val 65972"/>
            </a:avLst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68760" rIns="68760" tIns="34200" bIns="34200" anchor="ctr" rot="10800000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 Box 96"/>
          <p:cNvSpPr/>
          <p:nvPr/>
        </p:nvSpPr>
        <p:spPr>
          <a:xfrm>
            <a:off x="5791320" y="4724280"/>
            <a:ext cx="1066680" cy="855360"/>
          </a:xfrm>
          <a:prstGeom prst="rect">
            <a:avLst/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Pre-QC ssDNA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Calibri"/>
              </a:rPr>
              <a:t>(2D barcoded tubes in 96-well format rack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AutoShape 86"/>
          <p:cNvSpPr/>
          <p:nvPr/>
        </p:nvSpPr>
        <p:spPr>
          <a:xfrm>
            <a:off x="4267080" y="762120"/>
            <a:ext cx="171720" cy="285480"/>
          </a:xfrm>
          <a:prstGeom prst="rightArrow">
            <a:avLst>
              <a:gd name="adj1" fmla="val 45833"/>
              <a:gd name="adj2" fmla="val 65972"/>
            </a:avLst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68760" rIns="68760" tIns="34200" bIns="342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AutoShape 82"/>
          <p:cNvSpPr/>
          <p:nvPr/>
        </p:nvSpPr>
        <p:spPr>
          <a:xfrm>
            <a:off x="1676520" y="4971960"/>
            <a:ext cx="171360" cy="285840"/>
          </a:xfrm>
          <a:prstGeom prst="rightArrow">
            <a:avLst>
              <a:gd name="adj1" fmla="val 45833"/>
              <a:gd name="adj2" fmla="val 65972"/>
            </a:avLst>
          </a:prstGeom>
          <a:solidFill>
            <a:srgbClr val="ffffff"/>
          </a:solidFill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68760" rIns="68760" tIns="34200" bIns="342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343080"/>
                <a:tab algn="l" pos="685800"/>
                <a:tab algn="l" pos="1028880"/>
                <a:tab algn="l" pos="1371600"/>
                <a:tab algn="l" pos="1714680"/>
                <a:tab algn="l" pos="2057400"/>
                <a:tab algn="l" pos="2400480"/>
                <a:tab algn="l" pos="2743200"/>
                <a:tab algn="l" pos="3086280"/>
                <a:tab algn="l" pos="3429000"/>
                <a:tab algn="l" pos="3772080"/>
                <a:tab algn="l" pos="4114800"/>
                <a:tab algn="l" pos="4457880"/>
                <a:tab algn="l" pos="4800600"/>
                <a:tab algn="l" pos="5143680"/>
                <a:tab algn="l" pos="5486400"/>
                <a:tab algn="l" pos="5829480"/>
                <a:tab algn="l" pos="6172200"/>
                <a:tab algn="l" pos="6515280"/>
                <a:tab algn="l" pos="6858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Text Box 12"/>
          <p:cNvSpPr/>
          <p:nvPr/>
        </p:nvSpPr>
        <p:spPr>
          <a:xfrm>
            <a:off x="0" y="6477120"/>
            <a:ext cx="4572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Gill Sans"/>
              </a:rPr>
              <a:t>Lennon et al. Supplementary Information Figure S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2-07T18:23:03Z</dcterms:created>
  <dc:creator>Cindi Hoover</dc:creator>
  <dc:description/>
  <dc:language>en-US</dc:language>
  <cp:lastModifiedBy>Niall Lennon</cp:lastModifiedBy>
  <dcterms:modified xsi:type="dcterms:W3CDTF">2010-01-28T19:49:40Z</dcterms:modified>
  <cp:revision>16</cp:revision>
  <dc:subject/>
  <dc:title>1x100ng circ. vs. 1x300ng circ.</dc:title>
</cp:coreProperties>
</file>